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8" r:id="rId2"/>
  </p:sldIdLst>
  <p:sldSz cx="6858000" cy="9906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794" autoAdjust="0"/>
    <p:restoredTop sz="93321" autoAdjust="0"/>
  </p:normalViewPr>
  <p:slideViewPr>
    <p:cSldViewPr snapToGrid="0">
      <p:cViewPr>
        <p:scale>
          <a:sx n="120" d="100"/>
          <a:sy n="120" d="100"/>
        </p:scale>
        <p:origin x="-1552" y="37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noProof="0" smtClean="0"/>
              <a:t>Click to edit Master text styles</a:t>
            </a:r>
          </a:p>
          <a:p>
            <a:pPr lvl="1"/>
            <a:r>
              <a:rPr lang="en-US" altLang="zh-TW" noProof="0" smtClean="0"/>
              <a:t>Second level</a:t>
            </a:r>
          </a:p>
          <a:p>
            <a:pPr lvl="2"/>
            <a:r>
              <a:rPr lang="en-US" altLang="zh-TW" noProof="0" smtClean="0"/>
              <a:t>Third level</a:t>
            </a:r>
          </a:p>
          <a:p>
            <a:pPr lvl="3"/>
            <a:r>
              <a:rPr lang="en-US" altLang="zh-TW" noProof="0" smtClean="0"/>
              <a:t>Fourth level</a:t>
            </a:r>
          </a:p>
          <a:p>
            <a:pPr lvl="4"/>
            <a:r>
              <a:rPr lang="en-US" altLang="zh-TW" noProof="0" smtClean="0"/>
              <a:t>Fifth level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F6FEE8A5-9C87-404D-8492-3C853F20A90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1835355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Table S2. Receptors used in phylogenetic analysis and sequence alignment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F6FEE8A5-9C87-404D-8492-3C853F20A90D}" type="slidenum">
              <a:rPr lang="en-US" altLang="zh-TW" smtClean="0"/>
              <a:pPr>
                <a:defRPr/>
              </a:pPr>
              <a:t>1</a:t>
            </a:fld>
            <a:endParaRPr lang="en-US" altLang="zh-TW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314A88-9D02-42E0-891D-64D960C9DF0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680FD4-73B5-490F-8371-701FA60E7D45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33A7BAD-3541-4785-8DE5-D9954FF721C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D1682C-DB24-4FE6-A349-F8D592B9D55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B0C9B1-95AF-4B32-8F55-4F1179FA10A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BA8EDA-68D9-4822-9552-E74369906933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C6E1F-E25A-4FEB-957C-CF666FB3041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53F2C6-F33B-4503-A434-0A76B0D0B59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A231C3-DCE4-4A07-83C2-40310C49DAB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F947F9-F80A-4C34-B422-2B4F9DEDE6F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0D596E-D6BC-48A2-8C5E-EE267ED82720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fld id="{2C5B7070-85AC-4AC6-A406-85AA7B734B3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ext Box 4"/>
          <p:cNvSpPr txBox="1">
            <a:spLocks noChangeArrowheads="1"/>
          </p:cNvSpPr>
          <p:nvPr/>
        </p:nvSpPr>
        <p:spPr bwMode="auto">
          <a:xfrm>
            <a:off x="-22225" y="49213"/>
            <a:ext cx="15795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400" b="1" dirty="0">
                <a:ea typeface="新細明體" pitchFamily="18" charset="-120"/>
              </a:rPr>
              <a:t>TABLE S2</a:t>
            </a:r>
          </a:p>
        </p:txBody>
      </p:sp>
      <p:graphicFrame>
        <p:nvGraphicFramePr>
          <p:cNvPr id="37139" name="Group 23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8637181"/>
              </p:ext>
            </p:extLst>
          </p:nvPr>
        </p:nvGraphicFramePr>
        <p:xfrm>
          <a:off x="78929" y="365696"/>
          <a:ext cx="6696347" cy="9503131"/>
        </p:xfrm>
        <a:graphic>
          <a:graphicData uri="http://schemas.openxmlformats.org/drawingml/2006/table">
            <a:tbl>
              <a:tblPr lastCol="1"/>
              <a:tblGrid>
                <a:gridCol w="1871811"/>
                <a:gridCol w="1450011"/>
                <a:gridCol w="1898388"/>
                <a:gridCol w="1476137"/>
              </a:tblGrid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pecies</a:t>
                      </a:r>
                      <a:endParaRPr kumimoji="0" lang="en-US" altLang="zh-TW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cession/ Reference</a:t>
                      </a:r>
                      <a:endParaRPr kumimoji="0" lang="en-US" altLang="zh-TW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pecies</a:t>
                      </a:r>
                      <a:endParaRPr kumimoji="0" lang="en-US" altLang="zh-TW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cession/ Reference</a:t>
                      </a:r>
                      <a:endParaRPr kumimoji="0" lang="en-US" altLang="zh-TW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o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ur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AA0412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PTHRI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030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AA0446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PTHRI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6445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143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os taurus PTHRI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688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4084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A808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us scrofa PTHRI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99954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gallus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Q6308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orvegic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THRII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11235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enopus laevis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F1693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PTHRII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503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na ridibunda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L2683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enop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ropicali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THRII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XETP0000001757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ncorhynchus mykiss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U294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AL2444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 rubripes PAC1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D3569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orvegic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698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 rubripes PAC1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D3884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0368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ur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C156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o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ur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85136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er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AC1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DARP0000007027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vi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ri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0945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er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AC1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1346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noli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olinensi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ACAP0000000597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4084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Latimeri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halumnae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LACP0000001517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eniopygi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uttat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TGUP0000000034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4084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er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I6294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9842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ubrip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2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C8386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ubrip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TRUP000000454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ubrip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2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C8386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ur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J559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X5694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steroste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ule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GACP0000001557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n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ugulos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[27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</a:t>
                      </a:r>
                      <a:r>
                        <a:rPr kumimoji="0" lang="en-US" altLang="zh-TW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erio</a:t>
                      </a:r>
                      <a:r>
                        <a:rPr kumimoji="0" lang="en-US" altLang="zh-TW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P_00107595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VPAC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337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orvegic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SCT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11237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VPAC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353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ryctolag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unicul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SCT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754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orvegic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5893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o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ur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SCT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9249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eniopygi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uttat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TGUP0000000077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SCT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A6494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steroste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ule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2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GACP0000002318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SCT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1232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steroste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ule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2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GACP000000023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rotopter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olloi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SCT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DT9170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Latimeria</a:t>
                      </a:r>
                      <a:r>
                        <a:rPr kumimoji="0" lang="en-US" altLang="zh-TW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halumnae</a:t>
                      </a:r>
                      <a:r>
                        <a:rPr kumimoji="0" lang="en-US" altLang="zh-TW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NSLACP00000004890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enop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laevis SCT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DT917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ur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B0545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eniopygi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uttat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SCT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TGUP000000118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4084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er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W6513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SCT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16501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ubrip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C8258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kern="1200" baseline="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Latimeria</a:t>
                      </a:r>
                      <a:r>
                        <a:rPr lang="en-US" sz="1000" b="0" i="0" u="none" strike="noStrike" kern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en-US" sz="1000" b="0" i="0" u="none" strike="noStrike" kern="1200" baseline="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halumnae</a:t>
                      </a:r>
                      <a:r>
                        <a:rPr lang="en-US" sz="1000" b="0" i="0" u="none" strike="noStrike" kern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PRP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3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ENSLACP0000001408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ubrip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C8258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ubrip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C82589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6296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steroste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ule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GACP0000000438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ubrip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TRUP000000059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steroste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ule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GACP0000001696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steroste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ule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GACT0000002274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qual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anthia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[28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steroste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ule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GACP0000000711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eniopygi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uttat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TGUP0000000029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etraodon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igroviridi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TNIP0000002180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gallus V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P5868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ryzia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latip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ORLT0000002222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na ridibunda V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D0360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ryzia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latipe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ORLT0000001635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V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461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er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A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12452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V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583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er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B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DARP0000007026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orvegic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VPAC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68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ur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C156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5885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urat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HI-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[29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noli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olinensi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ACAT0000000648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er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HI-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X7992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eniopygi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uttata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P_002193375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erio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  <a:r>
                        <a:rPr kumimoji="0" lang="en-US" altLang="zh-TW" sz="1000" b="0" i="0" u="none" strike="noStrike" cap="none" normalizeH="0" baseline="-25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X5779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RPR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GALP000000084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75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</a:t>
                      </a:r>
                      <a:r>
                        <a:rPr kumimoji="0" lang="en-US" altLang="zh-TW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</a:t>
                      </a: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HRHR</a:t>
                      </a:r>
                      <a:r>
                        <a:rPr kumimoji="0" lang="en-US" altLang="zh-TW" sz="1000" b="0" i="0" u="none" strike="noStrike" cap="none" normalizeH="0" baseline="-25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Q024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00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佈景主題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3</TotalTime>
  <Words>373</Words>
  <Application>Microsoft Macintosh PowerPoint</Application>
  <PresentationFormat>A4 Paper (210x297 mm)</PresentationFormat>
  <Paragraphs>17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M KAL VAN</dc:creator>
  <cp:lastModifiedBy>Leo T.O. Lee</cp:lastModifiedBy>
  <cp:revision>228</cp:revision>
  <dcterms:created xsi:type="dcterms:W3CDTF">2010-04-22T03:44:22Z</dcterms:created>
  <dcterms:modified xsi:type="dcterms:W3CDTF">2012-12-04T03:03:33Z</dcterms:modified>
</cp:coreProperties>
</file>